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B24406D-7252-48A2-8E61-5B47A0067A00}" v="20" dt="2023-03-22T11:25:13.20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1" d="100"/>
          <a:sy n="61" d="100"/>
        </p:scale>
        <p:origin x="110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8636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4660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4959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9456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3669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443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021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8018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9022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2698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6834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84965C-83F5-4555-932A-BD684060A7EE}" type="datetimeFigureOut">
              <a:rPr lang="en-US" smtClean="0"/>
              <a:t>9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F40E4-9DEC-401F-88B1-A53C44BD58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5259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phic 6">
            <a:extLst>
              <a:ext uri="{FF2B5EF4-FFF2-40B4-BE49-F238E27FC236}">
                <a16:creationId xmlns:a16="http://schemas.microsoft.com/office/drawing/2014/main" id="{2BEAFB86-F250-253A-B003-FF2C9AD4982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l="1331" t="4315" r="16880"/>
          <a:stretch/>
        </p:blipFill>
        <p:spPr>
          <a:xfrm>
            <a:off x="6350" y="230242"/>
            <a:ext cx="3121269" cy="3100206"/>
          </a:xfrm>
          <a:prstGeom prst="rect">
            <a:avLst/>
          </a:prstGeom>
        </p:spPr>
      </p:pic>
      <p:pic>
        <p:nvPicPr>
          <p:cNvPr id="9" name="Graphic 8">
            <a:extLst>
              <a:ext uri="{FF2B5EF4-FFF2-40B4-BE49-F238E27FC236}">
                <a16:creationId xmlns:a16="http://schemas.microsoft.com/office/drawing/2014/main" id="{F91DDBDD-F357-3D99-2EA7-1EEBC30D9C8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 l="1331" t="4315" r="16880"/>
          <a:stretch/>
        </p:blipFill>
        <p:spPr>
          <a:xfrm>
            <a:off x="3121269" y="314325"/>
            <a:ext cx="3121269" cy="3100206"/>
          </a:xfrm>
          <a:prstGeom prst="rect">
            <a:avLst/>
          </a:prstGeom>
        </p:spPr>
      </p:pic>
      <p:pic>
        <p:nvPicPr>
          <p:cNvPr id="11" name="Graphic 10">
            <a:extLst>
              <a:ext uri="{FF2B5EF4-FFF2-40B4-BE49-F238E27FC236}">
                <a16:creationId xmlns:a16="http://schemas.microsoft.com/office/drawing/2014/main" id="{57A8CD1A-BA9D-0E0F-6A56-CE7CF9252F9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7"/>
              </a:ext>
            </a:extLst>
          </a:blip>
          <a:srcRect l="1330" t="4315" r="16880"/>
          <a:stretch/>
        </p:blipFill>
        <p:spPr>
          <a:xfrm>
            <a:off x="6244984" y="314325"/>
            <a:ext cx="3121269" cy="3100206"/>
          </a:xfrm>
          <a:prstGeom prst="rect">
            <a:avLst/>
          </a:prstGeom>
        </p:spPr>
      </p:pic>
      <p:pic>
        <p:nvPicPr>
          <p:cNvPr id="13" name="Graphic 12">
            <a:extLst>
              <a:ext uri="{FF2B5EF4-FFF2-40B4-BE49-F238E27FC236}">
                <a16:creationId xmlns:a16="http://schemas.microsoft.com/office/drawing/2014/main" id="{3D47C439-19C7-C6F3-FA57-A6C3FD0BDDD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5"/>
              </a:ext>
            </a:extLst>
          </a:blip>
          <a:srcRect l="84578" t="30989" r="1278" b="29721"/>
          <a:stretch/>
        </p:blipFill>
        <p:spPr>
          <a:xfrm>
            <a:off x="9357457" y="1127125"/>
            <a:ext cx="539750" cy="127298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0AD45AFA-8C61-43A3-7890-EA5A378FE425}"/>
              </a:ext>
            </a:extLst>
          </p:cNvPr>
          <p:cNvSpPr txBox="1"/>
          <p:nvPr/>
        </p:nvSpPr>
        <p:spPr>
          <a:xfrm>
            <a:off x="5369509" y="75630"/>
            <a:ext cx="5325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O/O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A286F6D-478E-D03D-5F9F-3EE7654FC6C6}"/>
              </a:ext>
            </a:extLst>
          </p:cNvPr>
          <p:cNvSpPr txBox="1"/>
          <p:nvPr/>
        </p:nvSpPr>
        <p:spPr>
          <a:xfrm>
            <a:off x="2179406" y="-8452"/>
            <a:ext cx="629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L/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C74F0C7-DCFD-8F2F-6253-74EF73B03D2A}"/>
              </a:ext>
            </a:extLst>
          </p:cNvPr>
          <p:cNvSpPr txBox="1"/>
          <p:nvPr/>
        </p:nvSpPr>
        <p:spPr>
          <a:xfrm>
            <a:off x="8168669" y="75629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L/BO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05F4746-BF3D-C5A0-AE8E-1CBC46880DC9}"/>
              </a:ext>
            </a:extLst>
          </p:cNvPr>
          <p:cNvSpPr txBox="1"/>
          <p:nvPr/>
        </p:nvSpPr>
        <p:spPr>
          <a:xfrm>
            <a:off x="6350" y="231773"/>
            <a:ext cx="2664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45FD189-A586-21BF-45C1-3CC1A52B7E39}"/>
              </a:ext>
            </a:extLst>
          </p:cNvPr>
          <p:cNvSpPr txBox="1"/>
          <p:nvPr/>
        </p:nvSpPr>
        <p:spPr>
          <a:xfrm>
            <a:off x="3139958" y="231773"/>
            <a:ext cx="2664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/>
              <a:t>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153D464-9206-C263-95EC-15F3A8313AEF}"/>
              </a:ext>
            </a:extLst>
          </p:cNvPr>
          <p:cNvSpPr txBox="1"/>
          <p:nvPr/>
        </p:nvSpPr>
        <p:spPr>
          <a:xfrm>
            <a:off x="6233204" y="231773"/>
            <a:ext cx="2600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/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F1E1650-F128-9844-3FAA-F61B7EB26797}"/>
              </a:ext>
            </a:extLst>
          </p:cNvPr>
          <p:cNvSpPr txBox="1"/>
          <p:nvPr/>
        </p:nvSpPr>
        <p:spPr>
          <a:xfrm>
            <a:off x="139560" y="3497083"/>
            <a:ext cx="9604515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/>
              <a:t>Supplementary Figure S4. </a:t>
            </a:r>
            <a:r>
              <a:rPr lang="en-US" sz="1600" dirty="0"/>
              <a:t>Bubble plot for top Gene Ontology (GO) function enrichment analysis for biological processes (BP) in black vs. control (A), middle vs. control (B), and black vs. middle (C) comparisons. </a:t>
            </a:r>
          </a:p>
        </p:txBody>
      </p:sp>
    </p:spTree>
    <p:extLst>
      <p:ext uri="{BB962C8B-B14F-4D97-AF65-F5344CB8AC3E}">
        <p14:creationId xmlns:p14="http://schemas.microsoft.com/office/powerpoint/2010/main" val="5187301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3</TotalTime>
  <Words>59</Words>
  <Application>Microsoft Office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briela Machaj</dc:creator>
  <cp:lastModifiedBy>Barbara Karpinska (Biosciences)</cp:lastModifiedBy>
  <cp:revision>6</cp:revision>
  <cp:lastPrinted>2023-03-24T09:10:18Z</cp:lastPrinted>
  <dcterms:created xsi:type="dcterms:W3CDTF">2023-03-20T09:37:55Z</dcterms:created>
  <dcterms:modified xsi:type="dcterms:W3CDTF">2023-09-08T01:02:56Z</dcterms:modified>
</cp:coreProperties>
</file>